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084D4-9E35-471D-9C07-63F4786F87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B3FF3-30B6-435D-8E26-49B59CF2A9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558BD-2FDC-4CEB-BFB0-25FBACA021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FFE92-390B-47A8-B51A-DD2E362CF6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D8089-6BE5-4D34-9B42-CE71A21F4E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DB817-5A3C-44A0-9B7C-7F9E4673A0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5175E-386B-4684-A161-CD681C40A4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BE17E-80A8-4F6A-8CF9-5E3990F589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959EE-5EE5-4CE9-AE0C-F854EB4479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AF961-4053-4E57-BE33-632662986F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95155-510A-43FE-B885-841F504039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487AA-06C3-4DCC-9E35-0448FA2582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A5C675-5493-4C06-B161-CF922BE8DBC1}" type="slidenum">
              <a:rPr b="0" lang="en-IN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1092240" y="870120"/>
            <a:ext cx="4673520" cy="5755680"/>
            <a:chOff x="1092240" y="870120"/>
            <a:chExt cx="4673520" cy="5755680"/>
          </a:xfrm>
        </p:grpSpPr>
        <p:graphicFrame>
          <p:nvGraphicFramePr>
            <p:cNvPr id="42" name="Chart 8"/>
            <p:cNvGraphicFramePr/>
            <p:nvPr/>
          </p:nvGraphicFramePr>
          <p:xfrm>
            <a:off x="1092240" y="870120"/>
            <a:ext cx="4673520" cy="28447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Chart 8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92240" y="870120"/>
                      <a:ext cx="4673520" cy="2844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44" name="Chart 5" descr=""/>
            <p:cNvPicPr/>
            <p:nvPr/>
          </p:nvPicPr>
          <p:blipFill>
            <a:blip r:embed="rId3"/>
            <a:stretch/>
          </p:blipFill>
          <p:spPr>
            <a:xfrm>
              <a:off x="1139760" y="3864960"/>
              <a:ext cx="4578120" cy="275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Box 1"/>
            <p:cNvSpPr/>
            <p:nvPr/>
          </p:nvSpPr>
          <p:spPr>
            <a:xfrm>
              <a:off x="1144800" y="3365280"/>
              <a:ext cx="270720" cy="326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Rectangle 6"/>
          <p:cNvSpPr/>
          <p:nvPr/>
        </p:nvSpPr>
        <p:spPr>
          <a:xfrm>
            <a:off x="1143000" y="7120080"/>
            <a:ext cx="4572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S4 Fig. </a:t>
            </a:r>
            <a:r>
              <a:rPr b="1" lang="en-IN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Total antioxidant and DPPH inhibition activity.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Total antioxidant (S4a) and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DPPH inhibition (S4b) activity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of cumin seedling under varying salinity stress. </a:t>
            </a:r>
            <a:r>
              <a:rPr b="0" lang="en-IN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Value represents the mean ± 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03T04:36:46Z</dcterms:created>
  <dc:creator>Avinash Mishra</dc:creator>
  <dc:description/>
  <dc:language>en-US</dc:language>
  <cp:lastModifiedBy>Avinash Mishra</cp:lastModifiedBy>
  <dcterms:modified xsi:type="dcterms:W3CDTF">2015-11-21T07:02:04Z</dcterms:modified>
  <cp:revision>33</cp:revision>
  <dc:subject/>
  <dc:title>PowerPoint Presentation</dc:title>
</cp:coreProperties>
</file>